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400800"/>
  <p:notesSz cx="64008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F7C478-F83F-4E84-ABE0-1FFD86CBC7E0}" v="6" dt="2025-04-07T13:57:49.0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10"/>
  </p:normalViewPr>
  <p:slideViewPr>
    <p:cSldViewPr snapToGrid="0" snapToObjects="1">
      <p:cViewPr varScale="1">
        <p:scale>
          <a:sx n="119" d="100"/>
          <a:sy n="119" d="100"/>
        </p:scale>
        <p:origin x="129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5/10/relationships/revisionInfo" Target="revisionInfo.xml"/><Relationship Id="rId4" Type="http://schemas.openxmlformats.org/officeDocument/2006/relationships/presProps" Target="pres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lightly, Yvonne M" userId="0a988f2b-75c1-4df1-9c05-8922a66f3f4b" providerId="ADAL" clId="{63F7C478-F83F-4E84-ABE0-1FFD86CBC7E0}"/>
    <pc:docChg chg="undo custSel modSld">
      <pc:chgData name="Golightly, Yvonne M" userId="0a988f2b-75c1-4df1-9c05-8922a66f3f4b" providerId="ADAL" clId="{63F7C478-F83F-4E84-ABE0-1FFD86CBC7E0}" dt="2025-04-07T13:59:58.155" v="292" actId="14100"/>
      <pc:docMkLst>
        <pc:docMk/>
      </pc:docMkLst>
      <pc:sldChg chg="addSp delSp modSp mod">
        <pc:chgData name="Golightly, Yvonne M" userId="0a988f2b-75c1-4df1-9c05-8922a66f3f4b" providerId="ADAL" clId="{63F7C478-F83F-4E84-ABE0-1FFD86CBC7E0}" dt="2025-04-07T13:59:58.155" v="292" actId="14100"/>
        <pc:sldMkLst>
          <pc:docMk/>
          <pc:sldMk cId="0" sldId="256"/>
        </pc:sldMkLst>
        <pc:spChg chg="mod">
          <ac:chgData name="Golightly, Yvonne M" userId="0a988f2b-75c1-4df1-9c05-8922a66f3f4b" providerId="ADAL" clId="{63F7C478-F83F-4E84-ABE0-1FFD86CBC7E0}" dt="2025-04-07T13:52:29.410" v="161" actId="1076"/>
          <ac:spMkLst>
            <pc:docMk/>
            <pc:sldMk cId="0" sldId="256"/>
            <ac:spMk id="15" creationId="{00000000-0000-0000-0000-000000000000}"/>
          </ac:spMkLst>
        </pc:spChg>
        <pc:spChg chg="mod">
          <ac:chgData name="Golightly, Yvonne M" userId="0a988f2b-75c1-4df1-9c05-8922a66f3f4b" providerId="ADAL" clId="{63F7C478-F83F-4E84-ABE0-1FFD86CBC7E0}" dt="2025-04-07T13:59:47.074" v="290" actId="1076"/>
          <ac:spMkLst>
            <pc:docMk/>
            <pc:sldMk cId="0" sldId="256"/>
            <ac:spMk id="16" creationId="{00000000-0000-0000-0000-000000000000}"/>
          </ac:spMkLst>
        </pc:spChg>
        <pc:spChg chg="add mod">
          <ac:chgData name="Golightly, Yvonne M" userId="0a988f2b-75c1-4df1-9c05-8922a66f3f4b" providerId="ADAL" clId="{63F7C478-F83F-4E84-ABE0-1FFD86CBC7E0}" dt="2025-04-07T13:55:42.722" v="187" actId="1076"/>
          <ac:spMkLst>
            <pc:docMk/>
            <pc:sldMk cId="0" sldId="256"/>
            <ac:spMk id="25" creationId="{2A4C0B34-7D20-AF6A-E4D1-911E18FADE32}"/>
          </ac:spMkLst>
        </pc:spChg>
        <pc:spChg chg="add mod">
          <ac:chgData name="Golightly, Yvonne M" userId="0a988f2b-75c1-4df1-9c05-8922a66f3f4b" providerId="ADAL" clId="{63F7C478-F83F-4E84-ABE0-1FFD86CBC7E0}" dt="2025-04-07T13:57:26.054" v="232" actId="20577"/>
          <ac:spMkLst>
            <pc:docMk/>
            <pc:sldMk cId="0" sldId="256"/>
            <ac:spMk id="27" creationId="{2715749E-BD70-FCAA-3833-8BD280A14ECD}"/>
          </ac:spMkLst>
        </pc:spChg>
        <pc:spChg chg="add mod">
          <ac:chgData name="Golightly, Yvonne M" userId="0a988f2b-75c1-4df1-9c05-8922a66f3f4b" providerId="ADAL" clId="{63F7C478-F83F-4E84-ABE0-1FFD86CBC7E0}" dt="2025-04-07T13:58:11.307" v="251" actId="1076"/>
          <ac:spMkLst>
            <pc:docMk/>
            <pc:sldMk cId="0" sldId="256"/>
            <ac:spMk id="28" creationId="{5D81F7FF-4396-3A0E-E115-A5DD308ABE63}"/>
          </ac:spMkLst>
        </pc:spChg>
        <pc:picChg chg="mod">
          <ac:chgData name="Golightly, Yvonne M" userId="0a988f2b-75c1-4df1-9c05-8922a66f3f4b" providerId="ADAL" clId="{63F7C478-F83F-4E84-ABE0-1FFD86CBC7E0}" dt="2025-04-07T13:59:40.706" v="288" actId="14100"/>
          <ac:picMkLst>
            <pc:docMk/>
            <pc:sldMk cId="0" sldId="256"/>
            <ac:picMk id="2" creationId="{00000000-0000-0000-0000-000000000000}"/>
          </ac:picMkLst>
        </pc:picChg>
        <pc:picChg chg="mod">
          <ac:chgData name="Golightly, Yvonne M" userId="0a988f2b-75c1-4df1-9c05-8922a66f3f4b" providerId="ADAL" clId="{63F7C478-F83F-4E84-ABE0-1FFD86CBC7E0}" dt="2025-04-07T13:59:53.765" v="291" actId="14100"/>
          <ac:picMkLst>
            <pc:docMk/>
            <pc:sldMk cId="0" sldId="256"/>
            <ac:picMk id="14" creationId="{00000000-0000-0000-0000-000000000000}"/>
          </ac:picMkLst>
        </pc:picChg>
        <pc:picChg chg="add del">
          <ac:chgData name="Golightly, Yvonne M" userId="0a988f2b-75c1-4df1-9c05-8922a66f3f4b" providerId="ADAL" clId="{63F7C478-F83F-4E84-ABE0-1FFD86CBC7E0}" dt="2025-04-07T13:32:00.203" v="2" actId="478"/>
          <ac:picMkLst>
            <pc:docMk/>
            <pc:sldMk cId="0" sldId="256"/>
            <ac:picMk id="19" creationId="{00000000-0000-0000-0000-000000000000}"/>
          </ac:picMkLst>
        </pc:picChg>
        <pc:picChg chg="add mod modCrop">
          <ac:chgData name="Golightly, Yvonne M" userId="0a988f2b-75c1-4df1-9c05-8922a66f3f4b" providerId="ADAL" clId="{63F7C478-F83F-4E84-ABE0-1FFD86CBC7E0}" dt="2025-04-07T13:33:32.550" v="32" actId="1038"/>
          <ac:picMkLst>
            <pc:docMk/>
            <pc:sldMk cId="0" sldId="256"/>
            <ac:picMk id="21" creationId="{D849F7D6-554A-88B5-C19D-42770461D2A9}"/>
          </ac:picMkLst>
        </pc:picChg>
        <pc:picChg chg="add mod modCrop">
          <ac:chgData name="Golightly, Yvonne M" userId="0a988f2b-75c1-4df1-9c05-8922a66f3f4b" providerId="ADAL" clId="{63F7C478-F83F-4E84-ABE0-1FFD86CBC7E0}" dt="2025-04-07T13:53:44.210" v="169" actId="1076"/>
          <ac:picMkLst>
            <pc:docMk/>
            <pc:sldMk cId="0" sldId="256"/>
            <ac:picMk id="22" creationId="{9893063D-2B9E-FB1B-03A5-4C8A1D3B8344}"/>
          </ac:picMkLst>
        </pc:picChg>
        <pc:picChg chg="add mod modCrop">
          <ac:chgData name="Golightly, Yvonne M" userId="0a988f2b-75c1-4df1-9c05-8922a66f3f4b" providerId="ADAL" clId="{63F7C478-F83F-4E84-ABE0-1FFD86CBC7E0}" dt="2025-04-07T13:54:09.666" v="173" actId="14100"/>
          <ac:picMkLst>
            <pc:docMk/>
            <pc:sldMk cId="0" sldId="256"/>
            <ac:picMk id="23" creationId="{EE36993A-2920-1083-A959-2103B9BC4BA3}"/>
          </ac:picMkLst>
        </pc:picChg>
        <pc:picChg chg="add mod ord">
          <ac:chgData name="Golightly, Yvonne M" userId="0a988f2b-75c1-4df1-9c05-8922a66f3f4b" providerId="ADAL" clId="{63F7C478-F83F-4E84-ABE0-1FFD86CBC7E0}" dt="2025-04-07T13:59:58.155" v="292" actId="14100"/>
          <ac:picMkLst>
            <pc:docMk/>
            <pc:sldMk cId="0" sldId="256"/>
            <ac:picMk id="26" creationId="{100AA8D3-289B-55E2-9AB9-92DC7F462C0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021321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notesSlide" Target="../notesSlides/notesSlide1.xml"/><Relationship Id="rId18" Type="http://schemas.openxmlformats.org/officeDocument/2006/relationships/image" Target="../media/image5.png"/><Relationship Id="rId26" Type="http://schemas.openxmlformats.org/officeDocument/2006/relationships/image" Target="../media/image13.png"/><Relationship Id="rId3" Type="http://schemas.openxmlformats.org/officeDocument/2006/relationships/tags" Target="../tags/tag3.xml"/><Relationship Id="rId21" Type="http://schemas.openxmlformats.org/officeDocument/2006/relationships/image" Target="../media/image8.png"/><Relationship Id="rId7" Type="http://schemas.openxmlformats.org/officeDocument/2006/relationships/tags" Target="../tags/tag7.xml"/><Relationship Id="rId12" Type="http://schemas.openxmlformats.org/officeDocument/2006/relationships/slideLayout" Target="../slideLayouts/slideLayout1.xml"/><Relationship Id="rId17" Type="http://schemas.openxmlformats.org/officeDocument/2006/relationships/image" Target="../media/image4.png"/><Relationship Id="rId25" Type="http://schemas.openxmlformats.org/officeDocument/2006/relationships/image" Target="../media/image12.JPG"/><Relationship Id="rId2" Type="http://schemas.openxmlformats.org/officeDocument/2006/relationships/tags" Target="../tags/tag2.xml"/><Relationship Id="rId16" Type="http://schemas.openxmlformats.org/officeDocument/2006/relationships/image" Target="../media/image3.png"/><Relationship Id="rId20" Type="http://schemas.openxmlformats.org/officeDocument/2006/relationships/image" Target="../media/image7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image" Target="../media/image11.JPG"/><Relationship Id="rId5" Type="http://schemas.openxmlformats.org/officeDocument/2006/relationships/tags" Target="../tags/tag5.xml"/><Relationship Id="rId15" Type="http://schemas.openxmlformats.org/officeDocument/2006/relationships/image" Target="../media/image2.png"/><Relationship Id="rId23" Type="http://schemas.openxmlformats.org/officeDocument/2006/relationships/image" Target="../media/image10.jpg"/><Relationship Id="rId10" Type="http://schemas.openxmlformats.org/officeDocument/2006/relationships/tags" Target="../tags/tag10.xml"/><Relationship Id="rId19" Type="http://schemas.openxmlformats.org/officeDocument/2006/relationships/image" Target="../media/image6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image" Target="../media/image1.png"/><Relationship Id="rId22" Type="http://schemas.openxmlformats.org/officeDocument/2006/relationships/image" Target="../media/image9.png"/><Relationship Id="rId27" Type="http://schemas.openxmlformats.org/officeDocument/2006/relationships/image" Target="../media/image1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age 8" descr="preencoded.png">
            <a:extLst>
              <a:ext uri="{FF2B5EF4-FFF2-40B4-BE49-F238E27FC236}">
                <a16:creationId xmlns:a16="http://schemas.microsoft.com/office/drawing/2014/main" id="{100AA8D3-289B-55E2-9AB9-92DC7F462C09}"/>
              </a:ext>
            </a:extLst>
          </p:cNvPr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3981264" y="4466703"/>
            <a:ext cx="5248124" cy="1791863"/>
          </a:xfrm>
          <a:prstGeom prst="rect">
            <a:avLst/>
          </a:prstGeom>
        </p:spPr>
      </p:pic>
      <p:pic>
        <p:nvPicPr>
          <p:cNvPr id="2" name="Image 0" descr="preencoded.png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0" y="2460466"/>
            <a:ext cx="4061080" cy="3839357"/>
          </a:xfrm>
          <a:prstGeom prst="rect">
            <a:avLst/>
          </a:prstGeom>
        </p:spPr>
      </p:pic>
      <p:pic>
        <p:nvPicPr>
          <p:cNvPr id="3" name="Image 1" descr="preencoded.png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3981265" y="451666"/>
            <a:ext cx="5248123" cy="2107934"/>
          </a:xfrm>
          <a:prstGeom prst="rect">
            <a:avLst/>
          </a:prstGeom>
        </p:spPr>
      </p:pic>
      <p:pic>
        <p:nvPicPr>
          <p:cNvPr id="4" name="Image 2" descr="preencoded.png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3997854" y="974430"/>
            <a:ext cx="500876" cy="1350847"/>
          </a:xfrm>
          <a:prstGeom prst="rect">
            <a:avLst/>
          </a:prstGeom>
        </p:spPr>
      </p:pic>
      <p:pic>
        <p:nvPicPr>
          <p:cNvPr id="5" name="Image 3" descr="preencoded.png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7346308" y="965042"/>
            <a:ext cx="682752" cy="1459992"/>
          </a:xfrm>
          <a:prstGeom prst="rect">
            <a:avLst/>
          </a:prstGeom>
        </p:spPr>
      </p:pic>
      <p:sp>
        <p:nvSpPr>
          <p:cNvPr id="6" name="Text 0"/>
          <p:cNvSpPr/>
          <p:nvPr/>
        </p:nvSpPr>
        <p:spPr>
          <a:xfrm>
            <a:off x="7160639" y="587772"/>
            <a:ext cx="854384" cy="476246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2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Knee Injury (yes/no)</a:t>
            </a:r>
            <a:endParaRPr lang="en-US" sz="1200" dirty="0"/>
          </a:p>
        </p:txBody>
      </p:sp>
      <p:sp>
        <p:nvSpPr>
          <p:cNvPr id="7" name="Text 1"/>
          <p:cNvSpPr/>
          <p:nvPr/>
        </p:nvSpPr>
        <p:spPr>
          <a:xfrm>
            <a:off x="8079870" y="583775"/>
            <a:ext cx="999054" cy="587663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138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Post-Injury Outcomes (KOOS) </a:t>
            </a:r>
            <a:endParaRPr lang="en-US" sz="1138" dirty="0"/>
          </a:p>
        </p:txBody>
      </p:sp>
      <p:pic>
        <p:nvPicPr>
          <p:cNvPr id="8" name="Image 4" descr="preencoded.png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8209564" y="994378"/>
            <a:ext cx="737616" cy="1466088"/>
          </a:xfrm>
          <a:prstGeom prst="rect">
            <a:avLst/>
          </a:prstGeom>
        </p:spPr>
      </p:pic>
      <p:pic>
        <p:nvPicPr>
          <p:cNvPr id="9" name="Image 5" descr="preencoded.png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4427715" y="1008553"/>
            <a:ext cx="2846832" cy="1317504"/>
          </a:xfrm>
          <a:prstGeom prst="rect">
            <a:avLst/>
          </a:prstGeom>
        </p:spPr>
      </p:pic>
      <p:sp>
        <p:nvSpPr>
          <p:cNvPr id="10" name="Text 2"/>
          <p:cNvSpPr/>
          <p:nvPr/>
        </p:nvSpPr>
        <p:spPr>
          <a:xfrm>
            <a:off x="4113607" y="614021"/>
            <a:ext cx="3040074" cy="353187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2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Biomarkers of Joint Metabolism at Matriculation and Graduation </a:t>
            </a:r>
            <a:endParaRPr lang="en-US" sz="1200" dirty="0"/>
          </a:p>
        </p:txBody>
      </p:sp>
      <p:pic>
        <p:nvPicPr>
          <p:cNvPr id="11" name="Image 6" descr="preencoded.png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-2303" y="486595"/>
            <a:ext cx="4098605" cy="2073005"/>
          </a:xfrm>
          <a:prstGeom prst="rect">
            <a:avLst/>
          </a:prstGeom>
        </p:spPr>
      </p:pic>
      <p:pic>
        <p:nvPicPr>
          <p:cNvPr id="12" name="Image 7" descr="preencoded.png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181801" y="893679"/>
            <a:ext cx="552967" cy="1491968"/>
          </a:xfrm>
          <a:prstGeom prst="rect">
            <a:avLst/>
          </a:prstGeom>
        </p:spPr>
      </p:pic>
      <p:sp>
        <p:nvSpPr>
          <p:cNvPr id="13" name="Text 3"/>
          <p:cNvSpPr/>
          <p:nvPr/>
        </p:nvSpPr>
        <p:spPr>
          <a:xfrm>
            <a:off x="894543" y="937723"/>
            <a:ext cx="3019599" cy="1447924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100000"/>
              </a:lnSpc>
              <a:buNone/>
            </a:pPr>
            <a:r>
              <a:rPr lang="en-US" sz="1200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mong military officers, investigate with novel methodologies the longitudinal relationships between:</a:t>
            </a:r>
            <a:endParaRPr lang="en-US" sz="1200" dirty="0"/>
          </a:p>
          <a:p>
            <a:pPr marL="182880" lvl="1" indent="-91440" algn="l">
              <a:lnSpc>
                <a:spcPct val="100000"/>
              </a:lnSpc>
              <a:spcBef>
                <a:spcPts val="400"/>
              </a:spcBef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Serum biomarkers of joint metabolism,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  <a:p>
            <a:pPr marL="182880" lvl="1" indent="-91440" algn="l">
              <a:lnSpc>
                <a:spcPct val="100000"/>
              </a:lnSpc>
              <a:spcBef>
                <a:spcPts val="400"/>
              </a:spcBef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Knee injury, and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  <a:p>
            <a:pPr marL="182880" lvl="1" indent="-91440" algn="l">
              <a:lnSpc>
                <a:spcPct val="100000"/>
              </a:lnSpc>
              <a:spcBef>
                <a:spcPts val="400"/>
              </a:spcBef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Knee Injury and Osteoarthritis Outcome Score (KOOS). 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</p:txBody>
      </p:sp>
      <p:pic>
        <p:nvPicPr>
          <p:cNvPr id="14" name="Image 8" descr="preencoded.png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3981264" y="2498428"/>
            <a:ext cx="5248124" cy="1973421"/>
          </a:xfrm>
          <a:prstGeom prst="rect">
            <a:avLst/>
          </a:prstGeom>
        </p:spPr>
      </p:pic>
      <p:sp>
        <p:nvSpPr>
          <p:cNvPr id="15" name="Text 4"/>
          <p:cNvSpPr/>
          <p:nvPr/>
        </p:nvSpPr>
        <p:spPr>
          <a:xfrm>
            <a:off x="4707356" y="4598889"/>
            <a:ext cx="3400425" cy="396538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4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KEY TAKE AWAY POINTS</a:t>
            </a:r>
            <a:endParaRPr lang="en-US" sz="1400" dirty="0"/>
          </a:p>
        </p:txBody>
      </p:sp>
      <p:sp>
        <p:nvSpPr>
          <p:cNvPr id="16" name="Text 5"/>
          <p:cNvSpPr/>
          <p:nvPr/>
        </p:nvSpPr>
        <p:spPr>
          <a:xfrm>
            <a:off x="4055137" y="4895793"/>
            <a:ext cx="5100378" cy="1345042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330200" lvl="1" indent="-235857" algn="l">
              <a:lnSpc>
                <a:spcPct val="100000"/>
              </a:lnSpc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Cohort of physically active military officers with and without injury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  <a:p>
            <a:pPr marL="330200" lvl="1" indent="-235857" algn="l">
              <a:lnSpc>
                <a:spcPct val="100000"/>
              </a:lnSpc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Confirmed known associations of joint metabolism biomarkers with </a:t>
            </a:r>
            <a:r>
              <a:rPr lang="en-US" sz="1200" u="sng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age and smoking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  <a:p>
            <a:pPr marL="330200" lvl="1" indent="-235857" algn="l">
              <a:lnSpc>
                <a:spcPct val="100000"/>
              </a:lnSpc>
              <a:buSzPct val="100000"/>
              <a:buChar char="●"/>
            </a:pP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Identified a </a:t>
            </a:r>
            <a:r>
              <a:rPr lang="en-US" sz="1200" b="1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"protective" knee phenotype</a:t>
            </a: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characterized by </a:t>
            </a:r>
            <a:r>
              <a:rPr lang="en-US" sz="1200" u="sng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high cartilage synthesis </a:t>
            </a:r>
            <a:r>
              <a:rPr lang="en-US" sz="1200" b="1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(high CPII)</a:t>
            </a: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and </a:t>
            </a:r>
            <a:r>
              <a:rPr lang="en-US" sz="1200" u="sng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lower bone and cartilage degradation</a:t>
            </a:r>
            <a:r>
              <a:rPr lang="en-US" sz="1200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(low C1,2C)</a:t>
            </a:r>
            <a:endParaRPr lang="en-US" sz="1200" dirty="0"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</p:txBody>
      </p:sp>
      <p:sp>
        <p:nvSpPr>
          <p:cNvPr id="17" name="Text 6"/>
          <p:cNvSpPr/>
          <p:nvPr/>
        </p:nvSpPr>
        <p:spPr>
          <a:xfrm>
            <a:off x="861160" y="640861"/>
            <a:ext cx="2514600" cy="278399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100000"/>
              </a:lnSpc>
              <a:buNone/>
            </a:pPr>
            <a:r>
              <a:rPr lang="en-US" sz="14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OBJECTIVE</a:t>
            </a:r>
            <a:endParaRPr lang="en-US" sz="1400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6BD6A94-9337-7AFC-5A00-07FB3C1E30BF}"/>
              </a:ext>
            </a:extLst>
          </p:cNvPr>
          <p:cNvSpPr/>
          <p:nvPr/>
        </p:nvSpPr>
        <p:spPr>
          <a:xfrm>
            <a:off x="0" y="0"/>
            <a:ext cx="9135291" cy="514828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algn="ctr"/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Novel Approach for Longitudinal Analysis of Serum Biomarkers of Joint Metabolism and Knee Injury in Military Officer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 descr="A diagram of a data flow&#10;&#10;AI-generated content may be incorrect.">
            <a:extLst>
              <a:ext uri="{FF2B5EF4-FFF2-40B4-BE49-F238E27FC236}">
                <a16:creationId xmlns:a16="http://schemas.microsoft.com/office/drawing/2014/main" id="{D849F7D6-554A-88B5-C19D-42770461D2A9}"/>
              </a:ext>
            </a:extLst>
          </p:cNvPr>
          <p:cNvPicPr>
            <a:picLocks noChangeAspect="1"/>
          </p:cNvPicPr>
          <p:nvPr/>
        </p:nvPicPr>
        <p:blipFill>
          <a:blip r:embed="rId23"/>
          <a:srcRect l="19750" t="2960" r="20101" b="15757"/>
          <a:stretch/>
        </p:blipFill>
        <p:spPr>
          <a:xfrm>
            <a:off x="361994" y="2578064"/>
            <a:ext cx="3386224" cy="355141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9893063D-2B9E-FB1B-03A5-4C8A1D3B8344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13" r="49326" b="53567"/>
          <a:stretch/>
        </p:blipFill>
        <p:spPr>
          <a:xfrm>
            <a:off x="7076944" y="2572419"/>
            <a:ext cx="1876158" cy="1579909"/>
          </a:xfrm>
          <a:prstGeom prst="rect">
            <a:avLst/>
          </a:prstGeom>
        </p:spPr>
      </p:pic>
      <p:pic>
        <p:nvPicPr>
          <p:cNvPr id="23" name="Content Placeholder 5">
            <a:extLst>
              <a:ext uri="{FF2B5EF4-FFF2-40B4-BE49-F238E27FC236}">
                <a16:creationId xmlns:a16="http://schemas.microsoft.com/office/drawing/2014/main" id="{EE36993A-2920-1083-A959-2103B9BC4BA3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2" r="66794" b="69163"/>
          <a:stretch/>
        </p:blipFill>
        <p:spPr>
          <a:xfrm>
            <a:off x="5427659" y="2559600"/>
            <a:ext cx="1528025" cy="159272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A4C0B34-7D20-AF6A-E4D1-911E18FADE32}"/>
              </a:ext>
            </a:extLst>
          </p:cNvPr>
          <p:cNvSpPr txBox="1"/>
          <p:nvPr/>
        </p:nvSpPr>
        <p:spPr>
          <a:xfrm>
            <a:off x="4113607" y="2550266"/>
            <a:ext cx="1261525" cy="18697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050" dirty="0">
                <a:solidFill>
                  <a:srgbClr val="000000"/>
                </a:solidFill>
                <a:effectLst/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First component of individual variation in biomarker levels among males at matriculation that are </a:t>
            </a:r>
            <a:r>
              <a:rPr lang="en-US" sz="1050" u="sng" dirty="0">
                <a:solidFill>
                  <a:srgbClr val="000000"/>
                </a:solidFill>
                <a:effectLst/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not</a:t>
            </a:r>
            <a:r>
              <a:rPr lang="en-US" sz="1050" dirty="0">
                <a:solidFill>
                  <a:srgbClr val="000000"/>
                </a:solidFill>
                <a:effectLst/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 related to biomarker levels at graduation and participant features</a:t>
            </a:r>
            <a:endParaRPr lang="en-US" sz="1050" dirty="0">
              <a:effectLst/>
              <a:latin typeface="Roboto" panose="02000000000000000000" pitchFamily="2" charset="0"/>
              <a:ea typeface="Roboto" panose="02000000000000000000" pitchFamily="2" charset="0"/>
              <a:cs typeface="Roboto" panose="02000000000000000000" pitchFamily="2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715749E-BD70-FCAA-3833-8BD280A14ECD}"/>
              </a:ext>
            </a:extLst>
          </p:cNvPr>
          <p:cNvSpPr txBox="1"/>
          <p:nvPr/>
        </p:nvSpPr>
        <p:spPr>
          <a:xfrm>
            <a:off x="5392437" y="4168786"/>
            <a:ext cx="16845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blue=injury, red=no injur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D81F7FF-4396-3A0E-E115-A5DD308ABE63}"/>
              </a:ext>
            </a:extLst>
          </p:cNvPr>
          <p:cNvSpPr txBox="1"/>
          <p:nvPr/>
        </p:nvSpPr>
        <p:spPr>
          <a:xfrm>
            <a:off x="7213521" y="4158583"/>
            <a:ext cx="1603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Roboto" panose="02000000000000000000" pitchFamily="2" charset="0"/>
                <a:ea typeface="Roboto" panose="02000000000000000000" pitchFamily="2" charset="0"/>
                <a:cs typeface="Roboto" panose="02000000000000000000" pitchFamily="2" charset="0"/>
              </a:rPr>
              <a:t>loading plot</a:t>
            </a:r>
          </a:p>
        </p:txBody>
      </p:sp>
      <p:pic>
        <p:nvPicPr>
          <p:cNvPr id="29" name="Image 0" descr="https://assets.cdn.biorender.com/assets/biorender-logo-blue.svg?cacheBust=0.4079797834568555"/>
          <p:cNvPicPr>
            <a:picLocks noChangeAspect="1"/>
          </p:cNvPicPr>
          <p:nvPr/>
        </p:nvPicPr>
        <p:blipFill>
          <a:blip r:embed="rId26">
            <a:extLst>
              <a:ext uri="{96DAC541-7B7A-43D3-8B79-37D633B846F1}">
                <asvg:svgBlip xmlns="" xmlns:asvg="http://schemas.microsoft.com/office/drawing/2016/SVG/main" r:embed="rId27"/>
              </a:ext>
            </a:extLst>
          </a:blip>
          <a:stretch>
            <a:fillRect/>
          </a:stretch>
        </p:blipFill>
        <p:spPr>
          <a:xfrm>
            <a:off x="8562536" y="5803155"/>
            <a:ext cx="507975" cy="326327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XPORTMETHOD" val="pptx_export_from_biorender"/>
  <p:tag name="ILLUSTRATIONID" val="67eadbd7c777ef1343361d75"/>
  <p:tag name="SLIDEID" val="883e0918-df9f-4401-b3e9-4278bde50d6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6a0df7dd-d02f-4f96-a678-e390bd9a3e3d&quot;:{&quot;id&quot;:&quot;6a0df7dd-d02f-4f96-a678-e390bd9a3e3d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83e0918-df9f-4401-b3e9-4278bde50d6e&quot;,&quot;order&quot;:&quot;5&quot;}},&quot;e922af2c-0f95-4b4a-a6b8-ef484339af59&quot;:{&quot;relativeTransform&quot;:{&quot;translate&quot;:{&quot;x&quot;:-77.20429429116102,&quot;y&quot;:-305.1890585128024},&quot;rotate&quot;:0,&quot;skewX&quot;:0,&quot;scale&quot;:{&quot;x&quot;:1,&quot;y&quot;:1}},&quot;type&quot;:&quot;FIGURE_OBJECT&quot;,&quot;id&quot;:&quot;e922af2c-0f95-4b4a-a6b8-ef484339af59&quot;,&quot;parent&quot;:{&quot;type&quot;:&quot;CHILD&quot;,&quot;parentId&quot;:&quot;883e0918-df9f-4401-b3e9-4278bde50d6e&quot;,&quot;order&quot;:&quot;5&quot;},&quot;name&quot;:&quot;Blood vial (serum, 1/2, with cap)&quot;,&quot;displayName&quot;:&quot;Blood vial (serum, 1/2, with cap)&quot;,&quot;source&quot;:{&quot;id&quot;:&quot;6332166040aec4585413c2e7&quot;,&quot;type&quot;:&quot;ASSETS&quot;},&quot;isPremium&quot;:true},&quot;c955827e-0e05-49c1-8ab7-500bd8c90fa9&quot;:{&quot;id&quot;:&quot;c955827e-0e05-49c1-8ab7-500bd8c90fa9&quot;,&quot;name&quot;:&quot;Blood vial (serum, 1/2)&quot;,&quot;displayName&quot;:&quot;&quot;,&quot;type&quot;:&quot;FIGURE_OBJECT&quot;,&quot;relativeTransform&quot;:{&quot;translate&quot;:{&quot;x&quot;:33.28192089724682,&quot;y&quot;:23.622488114098065},&quot;rotate&quot;:0,&quot;skewX&quot;:0,&quot;scale&quot;:{&quot;x&quot;:0.2006068901053935,&quot;y&quot;:0.2006068901053935}},&quot;image&quot;:{&quot;url&quot;:&quot;https://icons.biorender.com/biorender/6329f5e58dc9890028b7ac8a/20220920172137/image/blood-vial-serum-1-2.png&quot;,&quot;fallbackUrl&quot;:&quot;https://res.cloudinary.com/dlcjuc3ej/image/upload/v1663694497/xdl1mtzpgedcrtb7pmp6.svg#/keystone/api/icons/6329f5e58dc9890028b7ac8a/20220920172137/image/blood-vial-serum-1-2.svg&quot;,&quot;isPremium&quot;:false,&quot;size&quot;:{&quot;x&quot;:50,&quot;y&quot;:183.84615384615387}},&quot;source&quot;:{&quot;id&quot;:&quot;6329f5e58dc9890028b7ac8a&quot;,&quot;type&quot;:&quot;ASSETS&quot;},&quot;isPremium&quot;:false,&quot;parent&quot;:{&quot;type&quot;:&quot;CHILD&quot;,&quot;parentId&quot;:&quot;e922af2c-0f95-4b4a-a6b8-ef484339af59&quot;,&quot;order&quot;:&quot;2&quot;}},&quot;34b61edb-7099-4389-9160-bc55bfdec86b&quot;:{&quot;type&quot;:&quot;FIGURE_OBJECT&quot;,&quot;id&quot;:&quot;34b61edb-7099-4389-9160-bc55bfdec86b&quot;,&quot;name&quot;:&quot;Blood vial cap&quot;,&quot;relativeTransform&quot;:{&quot;translate&quot;:{&quot;x&quot;:33.219544208621606,&quot;y&quot;:2.234589520405601},&quot;rotate&quot;:0,&quot;skewX&quot;:0,&quot;scale&quot;:{&quot;x&quot;:0.15431299238876423,&quot;y&quot;:0.15431299238876423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e922af2c-0f95-4b4a-a6b8-ef484339af59&quot;,&quot;order&quot;:&quot;5&quot;}},&quot;b6891d6d-1bef-4877-a03c-e4303e18e2e1&quot;:{&quot;id&quot;:&quot;b6891d6d-1bef-4877-a03c-e4303e18e2e1&quot;,&quot;name&quot;:&quot;Soldier (gender-neutral)&quot;,&quot;displayName&quot;:&quot;&quot;,&quot;type&quot;:&quot;FIGURE_OBJECT&quot;,&quot;relativeTransform&quot;:{&quot;translate&quot;:{&quot;x&quot;:-430.998324925373,&quot;y&quot;:-233.93699999999998},&quot;rotate&quot;:0,&quot;skewX&quot;:0,&quot;scale&quot;:{&quot;x&quot;:0.3777974063018214,&quot;y&quot;:0.4215515808491417}},&quot;image&quot;:{&quot;url&quot;:&quot;https://icons.cdn.biorender.com/biorender/659d90e41755765045d2305a/20240109183305/image/659d90e41755765045d2305a.png&quot;,&quot;isPremium&quot;:false,&quot;isOrgIcon&quot;:false,&quot;size&quot;:{&quot;x&quot;:135,&quot;y&quot;:325.5882352941176}},&quot;source&quot;:{&quot;id&quot;:&quot;659d90e41755765045d2305a&quot;,&quot;version&quot;:&quot;20240109183305&quot;,&quot;type&quot;:&quot;ASSETS&quot;},&quot;isPremium&quot;:false,&quot;parent&quot;:{&quot;type&quot;:&quot;CHILD&quot;,&quot;parentId&quot;:&quot;883e0918-df9f-4401-b3e9-4278bde50d6e&quot;,&quot;order&quot;:&quot;9998&quot;}},&quot;f1b278dc-2ef3-409f-a112-c9f2fabdc7a9&quot;:{&quot;id&quot;:&quot;f1b278dc-2ef3-409f-a112-c9f2fabdc7a9&quot;,&quot;name&quot;:&quot;Adult male (lateral, with crutches)&quot;,&quot;displayName&quot;:&quot;&quot;,&quot;type&quot;:&quot;FIGURE_OBJECT&quot;,&quot;relativeTransform&quot;:{&quot;translate&quot;:{&quot;x&quot;:324.14091170701374,&quot;y&quot;:-194.88800000000003},&quot;rotate&quot;:0,&quot;skewX&quot;:0,&quot;scale&quot;:{&quot;x&quot;:0.6519834235088423,&quot;y&quot;:0.5789130434782611}},&quot;image&quot;:{&quot;url&quot;:&quot;https://icons.cdn.biorender.com/biorender/655266631fe3545824498510/20231113181219/image/655266631fe3545824498510.png&quot;,&quot;isPremium&quot;:false,&quot;isOrgIcon&quot;:false,&quot;size&quot;:{&quot;x&quot;:110,&quot;y&quot;:264.6769230769231}},&quot;source&quot;:{&quot;id&quot;:&quot;655266631fe3545824498510&quot;,&quot;version&quot;:&quot;20231113181219&quot;,&quot;type&quot;:&quot;ASSETS&quot;},&quot;isPremium&quot;:false,&quot;parent&quot;:{&quot;type&quot;:&quot;CHILD&quot;,&quot;parentId&quot;:&quot;883e0918-df9f-4401-b3e9-4278bde50d6e&quot;,&quot;order&quot;:&quot;99&quot;}},&quot;74d868a9-8502-4736-994e-04c5de7b8a61&quot;:{&quot;id&quot;:&quot;74d868a9-8502-4736-994e-04c5de7b8a61&quot;,&quot;type&quot;:&quot;FIGURE_OBJECT&quot;,&quot;relativeTransform&quot;:{&quot;translate&quot;:{&quot;x&quot;:324.5,&quot;y&quot;:-296.5002330097087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6,&quot;color&quot;:&quot;black&quot;,&quot;fontWeight&quot;:&quot;bold&quot;,&quot;fontStyle&quot;:&quot;normal&quot;,&quot;decoration&quot;:&quot;none&quot;},&quot;range&quot;:[0,6]}],&quot;text&quot;:&quot;Injury?&quot;}],&quot;_lastCaretLocation&quot;:{&quot;lineIndex&quot;:0,&quot;runIndex&quot;:-1,&quot;charIndex&quot;:-1,&quot;endOfLine&quot;:true}},&quot;format&quot;:&quot;BETTER_TEXT&quot;,&quot;size&quot;:{&quot;x&quot;:95.00000000000006,&quot;y&quot;:49.999533980582484},&quot;targetSize&quot;:{&quot;x&quot;:95.00000000000006,&quot;y&quot;:49.999533980582484}},&quot;parent&quot;:{&quot;type&quot;:&quot;CHILD&quot;,&quot;parentId&quot;:&quot;883e0918-df9f-4401-b3e9-4278bde50d6e&quot;,&quot;order&quot;:&quot;995&quot;}},&quot;7607758d-3b15-48cc-bf52-2d437402a989&quot;:{&quot;id&quot;:&quot;7607758d-3b15-48cc-bf52-2d437402a989&quot;,&quot;type&quot;:&quot;FIGURE_OBJECT&quot;,&quot;relativeTransform&quot;:{&quot;translate&quot;:{&quot;x&quot;:420,&quot;y&quot;:-296.49985383244217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5.172905525846703,&quot;color&quot;:&quot;black&quot;,&quot;fontWeight&quot;:&quot;bold&quot;,&quot;fontStyle&quot;:&quot;normal&quot;,&quot;decoration&quot;:&quot;none&quot;},&quot;range&quot;:[0,19]}],&quot;text&quot;:&quot;Post-injury outcomes&quot;}]},&quot;format&quot;:&quot;BETTER_TEXT&quot;,&quot;size&quot;:{&quot;x&quot;:120.00000000000014,&quot;y&quot;:50.00029233511593},&quot;targetSize&quot;:{&quot;x&quot;:120.00000000000014,&quot;y&quot;:50.00029233511593}},&quot;parent&quot;:{&quot;type&quot;:&quot;CHILD&quot;,&quot;parentId&quot;:&quot;883e0918-df9f-4401-b3e9-4278bde50d6e&quot;,&quot;order&quot;:&quot;997&quot;}},&quot;fad3a17f-1f03-4331-ae70-50660224746b&quot;:{&quot;relativeTransform&quot;:{&quot;translate&quot;:{&quot;x&quot;:424.00313976532544,&quot;y&quot;:-194.88766839368918},&quot;rotate&quot;:0},&quot;type&quot;:&quot;FIGURE_OBJECT&quot;,&quot;id&quot;:&quot;fad3a17f-1f03-4331-ae70-50660224746b&quot;,&quot;name&quot;:&quot;Knee joint (cross section, healthy, arthritic comparison)&quot;,&quot;displayName&quot;:&quot;Knee joint (cross section, healthy, arthritic comparison)&quot;,&quot;opacity&quot;:1,&quot;source&quot;:{&quot;id&quot;:&quot;5da5e6bbd1860900865ae083&quot;,&quot;type&quot;:&quot;ASSETS&quot;},&quot;pathStyles&quot;:[{&quot;type&quot;:&quot;FILL&quot;,&quot;fillStyle&quot;:&quot;rgb(0,0,0)&quot;}],&quot;isLocked&quot;:false,&quot;parent&quot;:{&quot;type&quot;:&quot;CHILD&quot;,&quot;parentId&quot;:&quot;883e0918-df9f-4401-b3e9-4278bde50d6e&quot;,&quot;order&quot;:&quot;999&quot;},&quot;isPremium&quot;:true},&quot;ddf0d1c7-80a5-4769-88d8-a3aeb7dae1c8&quot;:{&quot;type&quot;:&quot;FIGURE_OBJECT&quot;,&quot;id&quot;:&quot;ddf0d1c7-80a5-4769-88d8-a3aeb7dae1c8&quot;,&quot;name&quot;:&quot;Knee joint (cross-section, arthritic)&quot;,&quot;relativeTransform&quot;:{&quot;translate&quot;:{&quot;x&quot;:-2.2901755477260415,&quot;y&quot;:2.679752160680934},&quot;rotate&quot;:0,&quot;skewX&quot;:0,&quot;scale&quot;:{&quot;x&quot;:0.3304892134840046,&quot;y&quot;:0.3673351887927942}},&quot;opacity&quot;:1,&quot;image&quot;:{&quot;url&quot;:&quot;https://icons.biorender.com/biorender/5be4446c0e08e312001010a4/20190503161437/image/knee-joint-cross-section-arthritic.png&quot;,&quot;fallbackUrl&quot;:&quot;https://res.cloudinary.com/dlcjuc3ej/image/upload/v1556900077/eimpw8g7htghgwdu7gxy.svg#/keystone/api/icons/5be4446c0e08e312001010a4/20190503161437/image/knee-joint-cross-section-arthritic.svg&quot;,&quot;size&quot;:{&quot;x&quot;:245,&quot;y&quot;:381},&quot;isPremium&quot;:false},&quot;source&quot;:{&quot;id&quot;:&quot;5be4446c0e08e312001010a4&quot;,&quot;type&quot;:&quot;ASSETS&quot;},&quot;pathStyles&quot;:[{&quot;type&quot;:&quot;FILL&quot;,&quot;fillStyle&quot;:&quot;rgb(0,0,0)&quot;}],&quot;isLocked&quot;:false,&quot;parent&quot;:{&quot;type&quot;:&quot;CHILD&quot;,&quot;parentId&quot;:&quot;fad3a17f-1f03-4331-ae70-50660224746b&quot;,&quot;order&quot;:&quot;2&quot;}},&quot;29a928b4-78b1-49fc-85af-e492248cc746&quot;:{&quot;type&quot;:&quot;FIGURE_OBJECT&quot;,&quot;id&quot;:&quot;29a928b4-78b1-49fc-85af-e492248cc746&quot;,&quot;relativeTransform&quot;:{&quot;translate&quot;:{&quot;x&quot;:58.07576750722342,&quot;y&quot;:0},&quot;rotate&quot;:0,&quot;skewX&quot;:0,&quot;scale&quot;:{&quot;x&quot;:0.5278392885591604,&quot;y&quot;:1}},&quot;opacity&quot;:1,&quot;path&quot;:{&quot;type&quot;:&quot;RECT&quot;,&quot;size&quot;:{&quot;x&quot;:245,&quot;y&quot;:381}},&quot;pathStyles&quot;:[{&quot;type&quot;:&quot;FILL&quot;,&quot;fillStyle&quot;:&quot;#fff&quot;}],&quot;isFrozen&quot;:true,&quot;isLocked&quot;:false,&quot;parent&quot;:{&quot;type&quot;:&quot;CROP&quot;,&quot;parentId&quot;:&quot;ddf0d1c7-80a5-4769-88d8-a3aeb7dae1c8&quot;,&quot;order&quot;:&quot;5&quot;}},&quot;756c798c-659f-43f7-92f4-32a2d1925ce7&quot;:{&quot;type&quot;:&quot;FIGURE_OBJECT&quot;,&quot;id&quot;:&quot;756c798c-659f-43f7-92f4-32a2d1925ce7&quot;,&quot;name&quot;:&quot;Knee joint (cross-section)&quot;,&quot;relativeTransform&quot;:{&quot;translate&quot;:{&quot;x&quot;:-3.4060327775253754,&quot;y&quot;:1.6048425424142923},&quot;rotate&quot;:0,&quot;skewX&quot;:0,&quot;scale&quot;:{&quot;x&quot;:0.33612290170569226,&quot;y&quot;:0.3735969723611512}},&quot;opacity&quot;:1,&quot;image&quot;:{&quot;url&quot;:&quot;https://icons.biorender.com/biorender/5be354cc0e08e3120010102d/20181108141238/image/knee-joint-cross-section.png&quot;,&quot;fallbackUrl&quot;:&quot;https://res.cloudinary.com/dlcjuc3ej/image/upload/v1541686358/ap9dmgslipn9gnx6gibi.svg#/keystone/api/icons/5be354cc0e08e3120010102d/20181108141238/image/knee-joint-cross-section.svg&quot;,&quot;size&quot;:{&quot;x&quot;:207,&quot;y&quot;:380},&quot;isPremium&quot;:false},&quot;source&quot;:{&quot;id&quot;:&quot;5be354cc0e08e3120010102d&quot;,&quot;type&quot;:&quot;ASSETS&quot;},&quot;pathStyles&quot;:[{&quot;type&quot;:&quot;FILL&quot;,&quot;fillStyle&quot;:&quot;rgb(0,0,0)&quot;}],&quot;isLocked&quot;:false,&quot;parent&quot;:{&quot;type&quot;:&quot;CHILD&quot;,&quot;parentId&quot;:&quot;fad3a17f-1f03-4331-ae70-50660224746b&quot;,&quot;order&quot;:&quot;5&quot;}},&quot;50d34943-50b8-4d6f-84ff-77507abdae87&quot;:{&quot;type&quot;:&quot;FIGURE_OBJECT&quot;,&quot;id&quot;:&quot;50d34943-50b8-4d6f-84ff-77507abdae87&quot;,&quot;relativeTransform&quot;:{&quot;translate&quot;:{&quot;x&quot;:-52.52668421396925,&quot;y&quot;:0},&quot;rotate&quot;:0,&quot;skewX&quot;:0,&quot;scale&quot;:{&quot;x&quot;:0.4949357287118354,&quot;y&quot;:1}},&quot;opacity&quot;:1,&quot;path&quot;:{&quot;type&quot;:&quot;RECT&quot;,&quot;size&quot;:{&quot;x&quot;:207,&quot;y&quot;:380}},&quot;pathStyles&quot;:[{&quot;type&quot;:&quot;FILL&quot;,&quot;fillStyle&quot;:&quot;#fff&quot;}],&quot;isFrozen&quot;:true,&quot;isLocked&quot;:false,&quot;parent&quot;:{&quot;type&quot;:&quot;CROP&quot;,&quot;parentId&quot;:&quot;756c798c-659f-43f7-92f4-32a2d1925ce7&quot;,&quot;order&quot;:&quot;5&quot;}},&quot;a8603676-b601-47fb-b710-63c710261328&quot;:{&quot;type&quot;:&quot;FIGURE_OBJECT&quot;,&quot;id&quot;:&quot;a8603676-b601-47fb-b710-63c710261328&quot;,&quot;relativeTransform&quot;:{&quot;translate&quot;:{&quot;x&quot;:-3.9319764028399966,&quot;y&quot;:0},&quot;rotate&quot;:0},&quot;opacity&quot;:1,&quot;path&quot;:{&quot;type&quot;:&quot;POLY_LINE&quot;,&quot;points&quot;:[{&quot;x&quot;:0,&quot;y&quot;:-76.21763219571596},{&quot;x&quot;:0,&quot;y&quot;:76.21763219571596}],&quot;closed&quot;:false},&quot;pathStyles&quot;:[{&quot;type&quot;:&quot;FILL&quot;,&quot;fillStyle&quot;:&quot;transparent&quot;},{&quot;type&quot;:&quot;STROKE&quot;,&quot;strokeStyle&quot;:&quot;#232323&quot;,&quot;lineWidth&quot;:0.788706991550239,&quot;lineJoin&quot;:&quot;round&quot;,&quot;dashArray&quot;:[2,2]}],&quot;isLocked&quot;:false,&quot;parent&quot;:{&quot;type&quot;:&quot;CHILD&quot;,&quot;parentId&quot;:&quot;fad3a17f-1f03-4331-ae70-50660224746b&quot;,&quot;order&quot;:&quot;7&quot;}},&quot;172c8f63-ec04-45ab-b8d7-57b24abb06f9&quot;:{&quot;id&quot;:&quot;172c8f63-ec04-45ab-b8d7-57b24abb06f9&quot;,&quot;name&quot;:&quot;table with biomarkers.PNG&quot;,&quot;type&quot;:&quot;FIGURE_OBJECT&quot;,&quot;relativeTransform&quot;:{&quot;translate&quot;:{&quot;x&quot;:122.4995,&quot;y&quot;:-199.85943031657263},&quot;rotate&quot;:0,&quot;skewX&quot;:0,&quot;scale&quot;:{&quot;x&quot;:0.99641,&quot;y&quot;:1.1030416116341177}},&quot;image&quot;:{&quot;url&quot;:&quot;https://core.services.biorender.com/api/uploads/67eaf1270d0ea1710795fb8c/1743450407362_c5d3bd6a-6974-4026-bd9c-848f2bf2b376_icon.png&quot;,&quot;fallbackUrl&quot;:&quot;https://core.services.biorender.com/api/uploads/67eaf1270d0ea1710795fb8c/1743450407362_c5d3bd6a-6974-4026-bd9c-848f2bf2b376_icon.png&quot;,&quot;isPremium&quot;:false,&quot;isSignedURL&quot;:true,&quot;size&quot;:{&quot;x&quot;:300,&quot;y&quot;:129.89690721649484}},&quot;source&quot;:{&quot;id&quot;:&quot;67eaf1270d0ea1710795fb8c&quot;,&quot;type&quot;:&quot;UPLOADS&quot;},&quot;isPremium&quot;:false,&quot;parent&quot;:{&quot;type&quot;:&quot;CHILD&quot;,&quot;parentId&quot;:&quot;883e0918-df9f-4401-b3e9-4278bde50d6e&quot;,&quot;order&quot;:&quot;9995&quot;}},&quot;0ef6f407-63eb-43fc-90bc-5e68db933f22&quot;:{&quot;id&quot;:&quot;0ef6f407-63eb-43fc-90bc-5e68db933f22&quot;,&quot;type&quot;:&quot;FIGURE_OBJECT&quot;,&quot;relativeTransform&quot;:{&quot;translate&quot;:{&quot;x&quot;:119.04650000000007,&quot;y&quot;:-302.96000000000004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6,&quot;color&quot;:&quot;black&quot;,&quot;fontWeight&quot;:&quot;bold&quot;,&quot;fontStyle&quot;:&quot;normal&quot;,&quot;decoration&quot;:&quot;none&quot;},&quot;range&quot;:[0,71]}],&quot;text&quot;:&quot;Biomarkers of joint metabolism measured at matriculation and graduation &quot;,&quot;baseStyle&quot;:{&quot;fontFamily&quot;:&quot;Roboto&quot;,&quot;fontSize&quot;:16,&quot;color&quot;:&quot;black&quot;,&quot;fontWeight&quot;:&quot;normal&quot;,&quot;fontStyle&quot;:&quot;normal&quot;,&quot;decoration&quot;:&quot;none&quot;,&quot;script&quot;:&quot;none&quot;}}],&quot;_lastCaretLocation&quot;:{&quot;lineIndex&quot;:0,&quot;runIndex&quot;:0,&quot;charIndex&quot;:20}},&quot;format&quot;:&quot;BETTER_TEXT&quot;,&quot;size&quot;:{&quot;x&quot;:315.90699999999987,&quot;y&quot;:37.08},&quot;targetSize&quot;:{&quot;x&quot;:315.90699999999987,&quot;y&quot;:37.08}},&quot;parent&quot;:{&quot;type&quot;:&quot;CHILD&quot;,&quot;parentId&quot;:&quot;883e0918-df9f-4401-b3e9-4278bde50d6e&quot;,&quot;order&quot;:&quot;9997&quot;}},&quot;287042f9-e62b-4452-857c-793a0e71a005&quot;:{&quot;type&quot;:&quot;FIGURE_OBJECT&quot;,&quot;id&quot;:&quot;287042f9-e62b-4452-857c-793a0e71a005&quot;,&quot;relativeTransform&quot;:{&quot;translate&quot;:{&quot;x&quot;:-269.9839999999998,&quot;y&quot;:-224.21999999999994},&quot;rotate&quot;:0},&quot;opacity&quot;:1,&quot;path&quot;:{&quot;type&quot;:&quot;RECT&quot;,&quot;size&quot;:{&quot;x&quot;:395.99999999999994,&quot;y&quot;:212.5600000000001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9997&quot;}},&quot;fb16551d-0eae-4535-9fa0-e2acbd52d16c&quot;:{&quot;id&quot;:&quot;fb16551d-0eae-4535-9fa0-e2acbd52d16c&quot;,&quot;type&quot;:&quot;FIGURE_OBJECT&quot;,&quot;relativeTransform&quot;:{&quot;translate&quot;:{&quot;x&quot;:-242.9985,&quot;y&quot;:-213.4538333333333},&quot;rotate&quot;:0},&quot;text&quot;:{&quot;textData&quot;:{&quot;lineSpacing&quot;:&quot;normal&quot;,&quot;alignment&quot;:&quot;left&quot;,&quot;verticalAlign&quot;:&quot;TOP&quot;,&quot;lines&quot;:[{&quot;runs&quot;:[{&quot;range&quot;:[0,52],&quot;style&quot;:{&quot;fontWeight&quot;:&quot;normal&quot;,&quot;fontStyle&quot;:&quot;normal&quot;,&quot;fontSize&quot;:16,&quot;fontFamily&quot;:&quot;Roboto&quot;,&quot;color&quot;:&quot;black&quot;,&quot;decoration&quot;:&quot;none&quot;}}],&quot;text&quot;:&quot;To investigate the longitudinal relationships\nbetween&quot;,&quot;baseStyle&quot;:{&quot;fontFamily&quot;:&quot;Roboto&quot;,&quot;fontSize&quot;:16,&quot;color&quot;:&quot;black&quot;,&quot;fontWeight&quot;:&quot;bold&quot;,&quot;fontStyle&quot;:&quot;normal&quot;,&quot;decoration&quot;:&quot;none&quot;,&quot;script&quot;:&quot;none&quot;}},{&quot;textIndent&quot;:{&quot;type&quot;:&quot;bullet&quot;,&quot;indent&quot;:1,&quot;symbol&quot;:&quot;●&quot;,&quot;unit&quot;:&quot;levels&quot;},&quot;runs&quot;:[{&quot;range&quot;:[0,45],&quot;style&quot;:{&quot;fontWeight&quot;:&quot;normal&quot;,&quot;fontStyle&quot;:&quot;normal&quot;,&quot;fontSize&quot;:16,&quot;fontFamily&quot;:&quot;Roboto&quot;,&quot;color&quot;:&quot;black&quot;,&quot;decoration&quot;:&quot;none&quot;}}],&quot;text&quot;:&quot; serum biomarkers of joint    \t\t   metabolism,&quot;,&quot;baseStyle&quot;:{&quot;fontFamily&quot;:&quot;Roboto&quot;,&quot;fontSize&quot;:16,&quot;color&quot;:&quot;black&quot;,&quot;fontWeight&quot;:&quot;normal&quot;,&quot;fontStyle&quot;:&quot;normal&quot;,&quot;decoration&quot;:&quot;none&quot;,&quot;script&quot;:&quot;none&quot;}},{&quot;runs&quot;:[{&quot;range&quot;:[0,16],&quot;style&quot;:{&quot;fontWeight&quot;:&quot;normal&quot;,&quot;fontStyle&quot;:&quot;normal&quot;,&quot;fontSize&quot;:16,&quot;fontFamily&quot;:&quot;Roboto&quot;,&quot;color&quot;:&quot;black&quot;,&quot;decoration&quot;:&quot;none&quot;}}],&quot;text&quot;:&quot; knee injury, and&quot;,&quot;baseStyle&quot;:{&quot;fontFamily&quot;:&quot;Roboto&quot;,&quot;fontSize&quot;:16,&quot;color&quot;:&quot;black&quot;,&quot;fontWeight&quot;:&quot;bold&quot;,&quot;fontStyle&quot;:&quot;normal&quot;,&quot;decoration&quot;:&quot;none&quot;,&quot;script&quot;:&quot;none&quot;},&quot;textIndent&quot;:{&quot;type&quot;:&quot;bullet&quot;,&quot;indent&quot;:1,&quot;symbol&quot;:&quot;●&quot;,&quot;unit&quot;:&quot;levels&quot;}},{&quot;runs&quot;:[{&quot;range&quot;:[0,54],&quot;style&quot;:{&quot;fontWeight&quot;:&quot;normal&quot;,&quot;fontStyle&quot;:&quot;normal&quot;,&quot;fontSize&quot;:16,&quot;fontFamily&quot;:&quot;Roboto&quot;,&quot;color&quot;:&quot;black&quot;,&quot;decoration&quot;:&quot;none&quot;}}],&quot;text&quot;:&quot; Knee Injury and\nOsteoarthritis   Outcome Score (KOOS) &quot;,&quot;textIndent&quot;:{&quot;type&quot;:&quot;bullet&quot;,&quot;indent&quot;:1,&quot;symbol&quot;:&quot;●&quot;,&quot;unit&quot;:&quot;levels&quot;}},{&quot;runs&quot;:[{&quot;range&quot;:[0,25],&quot;style&quot;:{&quot;fontWeight&quot;:&quot;normal&quot;,&quot;fontStyle&quot;:&quot;normal&quot;,&quot;fontSize&quot;:16,&quot;fontFamily&quot;:&quot;Roboto&quot;,&quot;color&quot;:&quot;black&quot;,&quot;decoration&quot;:&quot;none&quot;}}],&quot;text&quot;:&quot;using novel methodologies.&quot;,&quot;baseStyle&quot;:{&quot;fontFamily&quot;:&quot;Roboto&quot;,&quot;fontSize&quot;:16,&quot;color&quot;:&quot;black&quot;,&quot;fontWeight&quot;:&quot;bold&quot;,&quot;fontStyle&quot;:&quot;normal&quot;,&quot;decoration&quot;:&quot;none&quot;,&quot;script&quot;:&quot;none&quot;}}],&quot;_lastCaretLocation&quot;:{&quot;lineIndex&quot;:1,&quot;runIndex&quot;:0,&quot;charIndex&quot;:35}},&quot;format&quot;:&quot;BETTER_TEXT&quot;,&quot;size&quot;:{&quot;x&quot;:324.997,&quot;y&quot;:152.01300000000006},&quot;targetSize&quot;:{&quot;x&quot;:324.997,&quot;y&quot;:152.01300000000006}},&quot;parent&quot;:{&quot;type&quot;:&quot;CHILD&quot;,&quot;parentId&quot;:&quot;883e0918-df9f-4401-b3e9-4278bde50d6e&quot;,&quot;order&quot;:&quot;9999&quot;}},&quot;e7beb73b-e34a-4bd9-b618-01143d1fe8be&quot;:{&quot;type&quot;:&quot;FIGURE_OBJECT&quot;,&quot;id&quot;:&quot;e7beb73b-e34a-4bd9-b618-01143d1fe8be&quot;,&quot;relativeTransform&quot;:{&quot;translate&quot;:{&quot;x&quot;:276.7499999999999,&quot;y&quot;:114.0265000000001},&quot;rotate&quot;:0,&quot;skewX&quot;:0,&quot;scale&quot;:{&quot;x&quot;:1,&quot;y&quot;:1}},&quot;opacity&quot;:1,&quot;path&quot;:{&quot;type&quot;:&quot;RECT&quot;,&quot;size&quot;:{&quot;x&quot;:374.776,&quot;y&quot;:432.94699999999995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99995&quot;}},&quot;bee77f87-cd6a-4ed1-84bf-2db373610327&quot;:{&quot;id&quot;:&quot;bee77f87-cd6a-4ed1-84bf-2db373610327&quot;,&quot;type&quot;:&quot;FIGURE_OBJECT&quot;,&quot;relativeTransform&quot;:{&quot;translate&quot;:{&quot;x&quot;:277.5,&quot;y&quot;:-69.68423998319669},&quot;rotate&quot;:0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,&quot;range&quot;:[0,19]}],&quot;text&quot;:&quot;KEY TAKE AWAY POINTS&quot;,&quot;baseStyle&quot;:{&quot;fontFamily&quot;:&quot;Roboto&quot;,&quot;fontSize&quot;:18.666666666666664,&quot;color&quot;:&quot;black&quot;,&quot;fontWeight&quot;:&quot;bold&quot;,&quot;fontStyle&quot;:&quot;normal&quot;,&quot;decoration&quot;:&quot;none&quot;,&quot;script&quot;:&quot;none&quot;}}],&quot;_lastCaretLocation&quot;:{&quot;lineIndex&quot;:1,&quot;runIndex&quot;:-1,&quot;charIndex&quot;:-1,&quot;endOfLine&quot;:true}},&quot;format&quot;:&quot;BETTER_TEXT&quot;,&quot;size&quot;:{&quot;x&quot;:356.99999999999994,&quot;y&quot;:41.631238509917715},&quot;targetSize&quot;:{&quot;x&quot;:356.99999999999994,&quot;y&quot;:41.631238509917715}},&quot;parent&quot;:{&quot;type&quot;:&quot;CHILD&quot;,&quot;parentId&quot;:&quot;883e0918-df9f-4401-b3e9-4278bde50d6e&quot;,&quot;order&quot;:&quot;99997&quot;}},&quot;e5a8b98f-c3c3-4bdf-a771-9b92f608d49e&quot;:{&quot;id&quot;:&quot;e5a8b98f-c3c3-4bdf-a771-9b92f608d49e&quot;,&quot;type&quot;:&quot;FIGURE_OBJECT&quot;,&quot;relativeTransform&quot;:{&quot;translate&quot;:{&quot;x&quot;:294.5000000000001,&quot;y&quot;:133.7766666666665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textIndent&quot;:{&quot;type&quot;:&quot;bullet&quot;,&quot;indent&quot;:1,&quot;symbol&quot;:&quot;●&quot;,&quot;unit&quot;:&quot;levels&quot;},&quot;runs&quot;:[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0,44]}],&quot;text&quot;:&quot;Cohort of physically active military officers&quot;},{&quot;textIndent&quot;:{&quot;type&quot;:&quot;bullet&quot;,&quot;indent&quot;:1,&quot;symbol&quot;:&quot;●&quot;,&quot;unit&quot;:&quot;levels&quot;},&quot;runs&quot;:[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0,35]}],&quot;text&quot;:&quot;Injury-mediated knee osteoarthritis &quot;},{&quot;textIndent&quot;:{&quot;type&quot;:&quot;bullet&quot;,&quot;indent&quot;:1,&quot;symbol&quot;:&quot;●&quot;,&quot;unit&quot;:&quot;levels&quot;},&quot;runs&quot;:[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0,39]}],&quot;text&quot;:&quot;Longitudinal measurements of biomarkers &quot;},{&quot;runs&quot;:[],&quot;text&quot;:&quot;&quot;,&quot;base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},{&quot;runs&quot;:[{&quot;style&quot;:{&quot;fontFamily&quot;:&quot;Roboto&quot;,&quot;fontSize&quot;:17.333333333333332,&quot;color&quot;:&quot;black&quot;,&quot;fontWeight&quot;:&quot;normal&quot;,&quot;fontStyle&quot;:&quot;normal&quot;,&quot;decoration&quot;:&quot;none&quot;},&quot;range&quot;:[0,67]},{&quot;style&quot;:{&quot;fontFamily&quot;:&quot;Roboto&quot;,&quot;fontSize&quot;:17.333333333333332,&quot;color&quot;:&quot;black&quot;,&quot;fontWeight&quot;:&quot;normal&quot;,&quot;fontStyle&quot;:&quot;normal&quot;,&quot;decoration&quot;:&quot;underline&quot;},&quot;range&quot;:[68,82]}],&quot;text&quot;:&quot;Confirmed known associations of of joint metabolism biomarkers with age and smoking&quot;,&quot;textIndent&quot;:{&quot;type&quot;:&quot;bullet&quot;,&quot;indent&quot;:1,&quot;symbol&quot;:&quot;●&quot;,&quot;unit&quot;:&quot;levels&quot;},&quot;base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},{&quot;runs&quot;:[],&quot;text&quot;:&quot;&quot;,&quot;textIndent&quot;:{&quot;type&quot;:&quot;none&quot;,&quot;indent&quot;:1,&quot;symbol&quot;:&quot; &quot;,&quot;unit&quot;:&quot;levels&quot;},&quot;baseStyle&quot;:{&quot;fontFamily&quot;:&quot;Roboto&quot;,&quot;fontSize&quot;:17.333333333333332,&quot;color&quot;:&quot;black&quot;,&quot;fontWeight&quot;:&quot;normal&quot;,&quot;fontStyle&quot;:&quot;normal&quot;,&quot;decoration&quot;:&quot;underline&quot;,&quot;script&quot;:&quot;none&quot;}},{&quot;textIndent&quot;:{&quot;type&quot;:&quot;bullet&quot;,&quot;indent&quot;:1,&quot;symbol&quot;:&quot;●&quot;,&quot;unit&quot;:&quot;levels&quot;},&quot;runs&quot;:[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0,12]},{&quot;style&quot;:{&quot;fontFamily&quot;:&quot;Roboto&quot;,&quot;fontSize&quot;:17.333333333333332,&quot;color&quot;:&quot;black&quot;,&quot;fontWeight&quot;:&quot;bold&quot;,&quot;fontStyle&quot;:&quot;normal&quot;,&quot;decoration&quot;:&quot;none&quot;,&quot;script&quot;:&quot;none&quot;},&quot;range&quot;:[13,39]},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40,57]},{&quot;style&quot;:{&quot;fontFamily&quot;:&quot;Roboto&quot;,&quot;fontSize&quot;:17.333333333333332,&quot;color&quot;:&quot;black&quot;,&quot;fontWeight&quot;:&quot;normal&quot;,&quot;fontStyle&quot;:&quot;normal&quot;,&quot;decoration&quot;:&quot;underline&quot;,&quot;script&quot;:&quot;none&quot;},&quot;range&quot;:[58,82]},{&quot;style&quot;:{&quot;fontFamily&quot;:&quot;Roboto&quot;,&quot;fontSize&quot;:17.333333333333332,&quot;color&quot;:&quot;black&quot;,&quot;fontWeight&quot;:&quot;bold&quot;,&quot;fontStyle&quot;:&quot;normal&quot;,&quot;decoration&quot;:&quot;none&quot;,&quot;script&quot;:&quot;none&quot;},&quot;range&quot;:[83,93]},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94,98]},{&quot;style&quot;:{&quot;fontFamily&quot;:&quot;Roboto&quot;,&quot;fontSize&quot;:17.333333333333332,&quot;color&quot;:&quot;black&quot;,&quot;fontWeight&quot;:&quot;normal&quot;,&quot;fontStyle&quot;:&quot;normal&quot;,&quot;decoration&quot;:&quot;underline&quot;,&quot;script&quot;:&quot;none&quot;},&quot;range&quot;:[99,134]},{&quot;style&quot;:{&quot;fontFamily&quot;:&quot;Roboto&quot;,&quot;fontSize&quot;:17.333333333333332,&quot;color&quot;:&quot;black&quot;,&quot;fontWeight&quot;:&quot;normal&quot;,&quot;fontStyle&quot;:&quot;normal&quot;,&quot;decoration&quot;:&quot;none&quot;,&quot;script&quot;:&quot;none&quot;},&quot;range&quot;:[135,135]},{&quot;style&quot;:{&quot;fontFamily&quot;:&quot;Roboto&quot;,&quot;fontSize&quot;:17.333333333333332,&quot;color&quot;:&quot;black&quot;,&quot;fontWeight&quot;:&quot;bold&quot;,&quot;fontStyle&quot;:&quot;normal&quot;,&quot;decoration&quot;:&quot;none&quot;,&quot;script&quot;:&quot;none&quot;},&quot;range&quot;:[136,146]}],&quot;text&quot;:&quot;Identified a \&quot;protective\&quot; knee phenotype characterized by high cartilage synthesis (high CPII) and lower bone and cartilage degradation (low C1,2C)&quot;,&quot;baseStyle&quot;:{&quot;fontFamily&quot;:&quot;Roboto&quot;,&quot;fontSize&quot;:17.333333333333332,&quot;color&quot;:&quot;black&quot;,&quot;fontWeight&quot;:&quot;bold&quot;,&quot;fontStyle&quot;:&quot;normal&quot;,&quot;decoration&quot;:&quot;underline&quot;,&quot;script&quot;:&quot;none&quot;}}],&quot;_lastCaretLocation&quot;:{&quot;lineIndex&quot;:5,&quot;runIndex&quot;:-1,&quot;charIndex&quot;:-1,&quot;endOfLine&quot;:true}},&quot;format&quot;:&quot;BETTER_TEXT&quot;,&quot;size&quot;:{&quot;x&quot;:322.99999999999994,&quot;y&quot;:333.45333333333315},&quot;targetSize&quot;:{&quot;x&quot;:322.99999999999994,&quot;y&quot;:333.45333333333315}},&quot;parent&quot;:{&quot;type&quot;:&quot;CHILD&quot;,&quot;parentId&quot;:&quot;883e0918-df9f-4401-b3e9-4278bde50d6e&quot;,&quot;order&quot;:&quot;99998&quot;}},&quot;1f12f621-3b18-4676-85e0-c4e684d9da4a&quot;:{&quot;id&quot;:&quot;1f12f621-3b18-4676-85e0-c4e684d9da4a&quot;,&quot;type&quot;:&quot;FIGURE_OBJECT&quot;,&quot;relativeTransform&quot;:{&quot;translate&quot;:{&quot;x&quot;:-252,&quot;y&quot;:-296.5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8.666666666666664,&quot;color&quot;:&quot;black&quot;,&quot;fontWeight&quot;:&quot;bold&quot;,&quot;fontStyle&quot;:&quot;normal&quot;,&quot;decoration&quot;:&quot;none&quot;},&quot;range&quot;:[0,8]}],&quot;text&quot;:&quot;OBJECTIVE&quot;}]},&quot;format&quot;:&quot;BETTER_TEXT&quot;,&quot;size&quot;:{&quot;x&quot;:264,&quot;y&quot;:50},&quot;targetSize&quot;:{&quot;x&quot;:264,&quot;y&quot;:50}},&quot;parent&quot;:{&quot;type&quot;:&quot;CHILD&quot;,&quot;parentId&quot;:&quot;883e0918-df9f-4401-b3e9-4278bde50d6e&quot;,&quot;order&quot;:&quot;99999&quot;}},&quot;7c24ed4f-63e6-4852-9463-38dc63eeb593&quot;:{&quot;type&quot;:&quot;FIGURE_OBJECT&quot;,&quot;id&quot;:&quot;7c24ed4f-63e6-4852-9463-38dc63eeb593&quot;,&quot;relativeTransform&quot;:{&quot;translate&quot;:{&quot;x&quot;:-200.25,&quot;y&quot;:114.0265},&quot;rotate&quot;:0},&quot;opacity&quot;:1,&quot;path&quot;:{&quot;type&quot;:&quot;RECT&quot;,&quot;size&quot;:{&quot;x&quot;:524.5,&quot;y&quot;:432.94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1&quot;}},&quot;e504153a-bbf5-4057-abe8-dc9cb4eb560f&quot;:{&quot;type&quot;:&quot;FIGURE_OBJECT&quot;,&quot;id&quot;:&quot;e504153a-bbf5-4057-abe8-dc9cb4eb560f&quot;,&quot;relativeTransform&quot;:{&quot;translate&quot;:{&quot;x&quot;:213,&quot;y&quot;:-224.22000000000003},&quot;rotate&quot;:0,&quot;skewX&quot;:0,&quot;scale&quot;:{&quot;x&quot;:1,&quot;y&quot;:1}},&quot;opacity&quot;:1,&quot;path&quot;:{&quot;type&quot;:&quot;RECT&quot;,&quot;size&quot;:{&quot;x&quot;:532,&quot;y&quot;:212.5599999999999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2&quot;}},&quot;ac937503-f7d5-41a8-a999-e46c622b4feb&quot;:{&quot;id&quot;:&quot;ac937503-f7d5-41a8-a999-e46c622b4feb&quot;,&quot;name&quot;:&quot;AJIVE diagram 2.PNG&quot;,&quot;type&quot;:&quot;FIGURE_OBJECT&quot;,&quot;relativeTransform&quot;:{&quot;translate&quot;:{&quot;x&quot;:-201,&quot;y&quot;:107.90400000000002},&quot;rotate&quot;:0,&quot;skewX&quot;:0,&quot;scale&quot;:{&quot;x&quot;:1.6666666666666659,&quot;y&quot;:2.1946368715083806}},&quot;image&quot;:{&quot;url&quot;:&quot;https://core.services.biorender.com/api/uploads/67ebe0ac2203ff31a16084c1/1743511724663_e10f772d-8503-435e-bf9c-110d151bdf7b_icon.png&quot;,&quot;fallbackUrl&quot;:&quot;https://core.services.biorender.com/api/uploads/67ebe0ac2203ff31a16084c1/1743511724663_e10f772d-8503-435e-bf9c-110d151bdf7b_icon.png&quot;,&quot;isPremium&quot;:false,&quot;isSignedURL&quot;:true,&quot;size&quot;:{&quot;x&quot;:300,&quot;y&quot;:180.80808080808083}},&quot;source&quot;:{&quot;id&quot;:&quot;67ebe0ac2203ff31a16084c1&quot;,&quot;type&quot;:&quot;UPLOADS&quot;},&quot;isPremium&quot;:false,&quot;parent&quot;:{&quot;type&quot;:&quot;CHILD&quot;,&quot;parentId&quot;:&quot;883e0918-df9f-4401-b3e9-4278bde50d6e&quot;,&quot;order&quot;:&quot;999995&quot;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b6891d6d-1bef-4877-a03c-e4303e18e2e1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b6891d6d-1bef-4877-a03c-e4303e18e2e1&quot;:{&quot;id&quot;:&quot;b6891d6d-1bef-4877-a03c-e4303e18e2e1&quot;,&quot;name&quot;:&quot;Soldier (gender-neutral)&quot;,&quot;displayName&quot;:&quot;&quot;,&quot;type&quot;:&quot;FIGURE_OBJECT&quot;,&quot;relativeTransform&quot;:{&quot;translate&quot;:{&quot;x&quot;:-430.998324925373,&quot;y&quot;:-233.93699999999998},&quot;rotate&quot;:0,&quot;skewX&quot;:0,&quot;scale&quot;:{&quot;x&quot;:0.3777974063018214,&quot;y&quot;:0.4215515808491417}},&quot;image&quot;:{&quot;url&quot;:&quot;https://icons.cdn.biorender.com/biorender/659d90e41755765045d2305a/20240109183305/image/659d90e41755765045d2305a.png&quot;,&quot;isPremium&quot;:false,&quot;isOrgIcon&quot;:false,&quot;size&quot;:{&quot;x&quot;:135,&quot;y&quot;:325.5882352941176}},&quot;source&quot;:{&quot;id&quot;:&quot;659d90e41755765045d2305a&quot;,&quot;version&quot;:&quot;20240109183305&quot;,&quot;type&quot;:&quot;ASSETS&quot;},&quot;isPremium&quot;:false,&quot;parent&quot;:{&quot;type&quot;:&quot;CHILD&quot;,&quot;parentId&quot;:&quot;883e0918-df9f-4401-b3e9-4278bde50d6e&quot;,&quot;order&quot;:&quot;9998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e7beb73b-e34a-4bd9-b618-01143d1fe8be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e7beb73b-e34a-4bd9-b618-01143d1fe8be&quot;:{&quot;type&quot;:&quot;FIGURE_OBJECT&quot;,&quot;id&quot;:&quot;e7beb73b-e34a-4bd9-b618-01143d1fe8be&quot;,&quot;relativeTransform&quot;:{&quot;translate&quot;:{&quot;x&quot;:276.7499999999999,&quot;y&quot;:114.0265000000001},&quot;rotate&quot;:0,&quot;skewX&quot;:0,&quot;scale&quot;:{&quot;x&quot;:1,&quot;y&quot;:1}},&quot;opacity&quot;:1,&quot;path&quot;:{&quot;type&quot;:&quot;RECT&quot;,&quot;size&quot;:{&quot;x&quot;:374.776,&quot;y&quot;:432.94699999999995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99995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e7beb73b-e34a-4bd9-b618-01143d1fe8be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e7beb73b-e34a-4bd9-b618-01143d1fe8be&quot;:{&quot;type&quot;:&quot;FIGURE_OBJECT&quot;,&quot;id&quot;:&quot;e7beb73b-e34a-4bd9-b618-01143d1fe8be&quot;,&quot;relativeTransform&quot;:{&quot;translate&quot;:{&quot;x&quot;:276.7499999999999,&quot;y&quot;:114.0265000000001},&quot;rotate&quot;:0,&quot;skewX&quot;:0,&quot;scale&quot;:{&quot;x&quot;:1,&quot;y&quot;:1}},&quot;opacity&quot;:1,&quot;path&quot;:{&quot;type&quot;:&quot;RECT&quot;,&quot;size&quot;:{&quot;x&quot;:374.776,&quot;y&quot;:432.94699999999995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99995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7c24ed4f-63e6-4852-9463-38dc63eeb593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7c24ed4f-63e6-4852-9463-38dc63eeb593&quot;:{&quot;type&quot;:&quot;FIGURE_OBJECT&quot;,&quot;id&quot;:&quot;7c24ed4f-63e6-4852-9463-38dc63eeb593&quot;,&quot;relativeTransform&quot;:{&quot;translate&quot;:{&quot;x&quot;:-200.25,&quot;y&quot;:114.0265},&quot;rotate&quot;:0},&quot;opacity&quot;:1,&quot;path&quot;:{&quot;type&quot;:&quot;RECT&quot;,&quot;size&quot;:{&quot;x&quot;:524.5,&quot;y&quot;:432.94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1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e504153a-bbf5-4057-abe8-dc9cb4eb560f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e504153a-bbf5-4057-abe8-dc9cb4eb560f&quot;:{&quot;type&quot;:&quot;FIGURE_OBJECT&quot;,&quot;id&quot;:&quot;e504153a-bbf5-4057-abe8-dc9cb4eb560f&quot;,&quot;relativeTransform&quot;:{&quot;translate&quot;:{&quot;x&quot;:213,&quot;y&quot;:-224.22000000000003},&quot;rotate&quot;:0,&quot;skewX&quot;:0,&quot;scale&quot;:{&quot;x&quot;:1,&quot;y&quot;:1}},&quot;opacity&quot;:1,&quot;path&quot;:{&quot;type&quot;:&quot;RECT&quot;,&quot;size&quot;:{&quot;x&quot;:532,&quot;y&quot;:212.5599999999999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2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e922af2c-0f95-4b4a-a6b8-ef484339af59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e922af2c-0f95-4b4a-a6b8-ef484339af59&quot;:{&quot;relativeTransform&quot;:{&quot;translate&quot;:{&quot;x&quot;:-77.20429429116102,&quot;y&quot;:-305.1890585128024},&quot;rotate&quot;:0,&quot;skewX&quot;:0,&quot;scale&quot;:{&quot;x&quot;:1,&quot;y&quot;:1}},&quot;type&quot;:&quot;FIGURE_OBJECT&quot;,&quot;id&quot;:&quot;e922af2c-0f95-4b4a-a6b8-ef484339af59&quot;,&quot;parent&quot;:{&quot;type&quot;:&quot;CHILD&quot;,&quot;parentId&quot;:&quot;883e0918-df9f-4401-b3e9-4278bde50d6e&quot;,&quot;order&quot;:&quot;5&quot;},&quot;name&quot;:&quot;Blood vial (serum, 1/2, with cap)&quot;,&quot;displayName&quot;:&quot;Blood vial (serum, 1/2, with cap)&quot;,&quot;source&quot;:{&quot;id&quot;:&quot;6332166040aec4585413c2e7&quot;,&quot;type&quot;:&quot;ASSETS&quot;},&quot;isPremium&quot;:true},&quot;c955827e-0e05-49c1-8ab7-500bd8c90fa9&quot;:{&quot;id&quot;:&quot;c955827e-0e05-49c1-8ab7-500bd8c90fa9&quot;,&quot;name&quot;:&quot;Blood vial (serum, 1/2)&quot;,&quot;displayName&quot;:&quot;&quot;,&quot;type&quot;:&quot;FIGURE_OBJECT&quot;,&quot;relativeTransform&quot;:{&quot;translate&quot;:{&quot;x&quot;:33.28192089724682,&quot;y&quot;:23.622488114098065},&quot;rotate&quot;:0,&quot;skewX&quot;:0,&quot;scale&quot;:{&quot;x&quot;:0.2006068901053935,&quot;y&quot;:0.2006068901053935}},&quot;image&quot;:{&quot;url&quot;:&quot;https://icons.biorender.com/biorender/6329f5e58dc9890028b7ac8a/20220920172137/image/blood-vial-serum-1-2.png&quot;,&quot;fallbackUrl&quot;:&quot;https://res.cloudinary.com/dlcjuc3ej/image/upload/v1663694497/xdl1mtzpgedcrtb7pmp6.svg#/keystone/api/icons/6329f5e58dc9890028b7ac8a/20220920172137/image/blood-vial-serum-1-2.svg&quot;,&quot;isPremium&quot;:false,&quot;size&quot;:{&quot;x&quot;:50,&quot;y&quot;:183.84615384615387}},&quot;source&quot;:{&quot;id&quot;:&quot;6329f5e58dc9890028b7ac8a&quot;,&quot;type&quot;:&quot;ASSETS&quot;},&quot;isPremium&quot;:false,&quot;parent&quot;:{&quot;type&quot;:&quot;CHILD&quot;,&quot;parentId&quot;:&quot;e922af2c-0f95-4b4a-a6b8-ef484339af59&quot;,&quot;order&quot;:&quot;2&quot;}},&quot;34b61edb-7099-4389-9160-bc55bfdec86b&quot;:{&quot;type&quot;:&quot;FIGURE_OBJECT&quot;,&quot;id&quot;:&quot;34b61edb-7099-4389-9160-bc55bfdec86b&quot;,&quot;name&quot;:&quot;Blood vial cap&quot;,&quot;relativeTransform&quot;:{&quot;translate&quot;:{&quot;x&quot;:33.219544208621606,&quot;y&quot;:2.234589520405601},&quot;rotate&quot;:0,&quot;skewX&quot;:0,&quot;scale&quot;:{&quot;x&quot;:0.15431299238876423,&quot;y&quot;:0.15431299238876423}},&quot;opacity&quot;:1,&quot;image&quot;:{&quot;url&quot;:&quot;https://icons.biorender.com/biorender/5dbafea2c9e7d80004b85b5f/20191031153357/image/blood-vial-cap.png&quot;,&quot;fallbackUrl&quot;:&quot;https://res.cloudinary.com/dlcjuc3ej/image/upload/v1572536037/xpaz3jnhluv07ckoqfe9.svg#/keystone/api/icons/5dbafea2c9e7d80004b85b5f/20191031153357/image/blood-vial-cap.svg&quot;,&quot;size&quot;:{&quot;x&quot;:65,&quot;y&quot;:79},&quot;isPremium&quot;:false},&quot;source&quot;:{&quot;id&quot;:&quot;5dbafea2c9e7d80004b85b5f&quot;,&quot;type&quot;:&quot;ASSETS&quot;},&quot;pathStyles&quot;:[{&quot;type&quot;:&quot;FILL&quot;,&quot;fillStyle&quot;:&quot;rgb(0,0,0)&quot;}],&quot;isLocked&quot;:false,&quot;parent&quot;:{&quot;type&quot;:&quot;CHILD&quot;,&quot;parentId&quot;:&quot;e922af2c-0f95-4b4a-a6b8-ef484339af59&quot;,&quot;order&quot;:&quot;5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f1b278dc-2ef3-409f-a112-c9f2fabdc7a9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f1b278dc-2ef3-409f-a112-c9f2fabdc7a9&quot;:{&quot;id&quot;:&quot;f1b278dc-2ef3-409f-a112-c9f2fabdc7a9&quot;,&quot;name&quot;:&quot;Adult male (lateral, with crutches)&quot;,&quot;displayName&quot;:&quot;&quot;,&quot;type&quot;:&quot;FIGURE_OBJECT&quot;,&quot;relativeTransform&quot;:{&quot;translate&quot;:{&quot;x&quot;:324.14091170701374,&quot;y&quot;:-194.88800000000003},&quot;rotate&quot;:0,&quot;skewX&quot;:0,&quot;scale&quot;:{&quot;x&quot;:0.6519834235088423,&quot;y&quot;:0.5789130434782611}},&quot;image&quot;:{&quot;url&quot;:&quot;https://icons.cdn.biorender.com/biorender/655266631fe3545824498510/20231113181219/image/655266631fe3545824498510.png&quot;,&quot;isPremium&quot;:false,&quot;isOrgIcon&quot;:false,&quot;size&quot;:{&quot;x&quot;:110,&quot;y&quot;:264.6769230769231}},&quot;source&quot;:{&quot;id&quot;:&quot;655266631fe3545824498510&quot;,&quot;version&quot;:&quot;20231113181219&quot;,&quot;type&quot;:&quot;ASSETS&quot;},&quot;isPremium&quot;:false,&quot;parent&quot;:{&quot;type&quot;:&quot;CHILD&quot;,&quot;parentId&quot;:&quot;883e0918-df9f-4401-b3e9-4278bde50d6e&quot;,&quot;order&quot;:&quot;99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fad3a17f-1f03-4331-ae70-50660224746b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fad3a17f-1f03-4331-ae70-50660224746b&quot;:{&quot;relativeTransform&quot;:{&quot;translate&quot;:{&quot;x&quot;:424.00313976532544,&quot;y&quot;:-194.88766839368918},&quot;rotate&quot;:0},&quot;type&quot;:&quot;FIGURE_OBJECT&quot;,&quot;id&quot;:&quot;fad3a17f-1f03-4331-ae70-50660224746b&quot;,&quot;name&quot;:&quot;Knee joint (cross section, healthy, arthritic comparison)&quot;,&quot;displayName&quot;:&quot;Knee joint (cross section, healthy, arthritic comparison)&quot;,&quot;opacity&quot;:1,&quot;source&quot;:{&quot;id&quot;:&quot;5da5e6bbd1860900865ae083&quot;,&quot;type&quot;:&quot;ASSETS&quot;},&quot;pathStyles&quot;:[{&quot;type&quot;:&quot;FILL&quot;,&quot;fillStyle&quot;:&quot;rgb(0,0,0)&quot;}],&quot;isLocked&quot;:false,&quot;parent&quot;:{&quot;type&quot;:&quot;CHILD&quot;,&quot;parentId&quot;:&quot;883e0918-df9f-4401-b3e9-4278bde50d6e&quot;,&quot;order&quot;:&quot;999&quot;},&quot;isPremium&quot;:true},&quot;ddf0d1c7-80a5-4769-88d8-a3aeb7dae1c8&quot;:{&quot;type&quot;:&quot;FIGURE_OBJECT&quot;,&quot;id&quot;:&quot;ddf0d1c7-80a5-4769-88d8-a3aeb7dae1c8&quot;,&quot;name&quot;:&quot;Knee joint (cross-section, arthritic)&quot;,&quot;relativeTransform&quot;:{&quot;translate&quot;:{&quot;x&quot;:-2.2901755477260415,&quot;y&quot;:2.679752160680934},&quot;rotate&quot;:0,&quot;skewX&quot;:0,&quot;scale&quot;:{&quot;x&quot;:0.3304892134840046,&quot;y&quot;:0.3673351887927942}},&quot;opacity&quot;:1,&quot;image&quot;:{&quot;url&quot;:&quot;https://icons.biorender.com/biorender/5be4446c0e08e312001010a4/20190503161437/image/knee-joint-cross-section-arthritic.png&quot;,&quot;fallbackUrl&quot;:&quot;https://res.cloudinary.com/dlcjuc3ej/image/upload/v1556900077/eimpw8g7htghgwdu7gxy.svg#/keystone/api/icons/5be4446c0e08e312001010a4/20190503161437/image/knee-joint-cross-section-arthritic.svg&quot;,&quot;size&quot;:{&quot;x&quot;:245,&quot;y&quot;:381},&quot;isPremium&quot;:false},&quot;source&quot;:{&quot;id&quot;:&quot;5be4446c0e08e312001010a4&quot;,&quot;type&quot;:&quot;ASSETS&quot;},&quot;pathStyles&quot;:[{&quot;type&quot;:&quot;FILL&quot;,&quot;fillStyle&quot;:&quot;rgb(0,0,0)&quot;}],&quot;isLocked&quot;:false,&quot;parent&quot;:{&quot;type&quot;:&quot;CHILD&quot;,&quot;parentId&quot;:&quot;fad3a17f-1f03-4331-ae70-50660224746b&quot;,&quot;order&quot;:&quot;2&quot;}},&quot;29a928b4-78b1-49fc-85af-e492248cc746&quot;:{&quot;type&quot;:&quot;FIGURE_OBJECT&quot;,&quot;id&quot;:&quot;29a928b4-78b1-49fc-85af-e492248cc746&quot;,&quot;relativeTransform&quot;:{&quot;translate&quot;:{&quot;x&quot;:58.07576750722342,&quot;y&quot;:0},&quot;rotate&quot;:0,&quot;skewX&quot;:0,&quot;scale&quot;:{&quot;x&quot;:0.5278392885591604,&quot;y&quot;:1}},&quot;opacity&quot;:1,&quot;path&quot;:{&quot;type&quot;:&quot;RECT&quot;,&quot;size&quot;:{&quot;x&quot;:245,&quot;y&quot;:381}},&quot;pathStyles&quot;:[{&quot;type&quot;:&quot;FILL&quot;,&quot;fillStyle&quot;:&quot;#fff&quot;}],&quot;isFrozen&quot;:true,&quot;isLocked&quot;:false,&quot;parent&quot;:{&quot;type&quot;:&quot;CROP&quot;,&quot;parentId&quot;:&quot;ddf0d1c7-80a5-4769-88d8-a3aeb7dae1c8&quot;,&quot;order&quot;:&quot;5&quot;}},&quot;756c798c-659f-43f7-92f4-32a2d1925ce7&quot;:{&quot;type&quot;:&quot;FIGURE_OBJECT&quot;,&quot;id&quot;:&quot;756c798c-659f-43f7-92f4-32a2d1925ce7&quot;,&quot;name&quot;:&quot;Knee joint (cross-section)&quot;,&quot;relativeTransform&quot;:{&quot;translate&quot;:{&quot;x&quot;:-3.4060327775253754,&quot;y&quot;:1.6048425424142923},&quot;rotate&quot;:0,&quot;skewX&quot;:0,&quot;scale&quot;:{&quot;x&quot;:0.33612290170569226,&quot;y&quot;:0.3735969723611512}},&quot;opacity&quot;:1,&quot;image&quot;:{&quot;url&quot;:&quot;https://icons.biorender.com/biorender/5be354cc0e08e3120010102d/20181108141238/image/knee-joint-cross-section.png&quot;,&quot;fallbackUrl&quot;:&quot;https://res.cloudinary.com/dlcjuc3ej/image/upload/v1541686358/ap9dmgslipn9gnx6gibi.svg#/keystone/api/icons/5be354cc0e08e3120010102d/20181108141238/image/knee-joint-cross-section.svg&quot;,&quot;size&quot;:{&quot;x&quot;:207,&quot;y&quot;:380},&quot;isPremium&quot;:false},&quot;source&quot;:{&quot;id&quot;:&quot;5be354cc0e08e3120010102d&quot;,&quot;type&quot;:&quot;ASSETS&quot;},&quot;pathStyles&quot;:[{&quot;type&quot;:&quot;FILL&quot;,&quot;fillStyle&quot;:&quot;rgb(0,0,0)&quot;}],&quot;isLocked&quot;:false,&quot;parent&quot;:{&quot;type&quot;:&quot;CHILD&quot;,&quot;parentId&quot;:&quot;fad3a17f-1f03-4331-ae70-50660224746b&quot;,&quot;order&quot;:&quot;5&quot;}},&quot;50d34943-50b8-4d6f-84ff-77507abdae87&quot;:{&quot;type&quot;:&quot;FIGURE_OBJECT&quot;,&quot;id&quot;:&quot;50d34943-50b8-4d6f-84ff-77507abdae87&quot;,&quot;relativeTransform&quot;:{&quot;translate&quot;:{&quot;x&quot;:-52.52668421396925,&quot;y&quot;:0},&quot;rotate&quot;:0,&quot;skewX&quot;:0,&quot;scale&quot;:{&quot;x&quot;:0.4949357287118354,&quot;y&quot;:1}},&quot;opacity&quot;:1,&quot;path&quot;:{&quot;type&quot;:&quot;RECT&quot;,&quot;size&quot;:{&quot;x&quot;:207,&quot;y&quot;:380}},&quot;pathStyles&quot;:[{&quot;type&quot;:&quot;FILL&quot;,&quot;fillStyle&quot;:&quot;#fff&quot;}],&quot;isFrozen&quot;:true,&quot;isLocked&quot;:false,&quot;parent&quot;:{&quot;type&quot;:&quot;CROP&quot;,&quot;parentId&quot;:&quot;756c798c-659f-43f7-92f4-32a2d1925ce7&quot;,&quot;order&quot;:&quot;5&quot;}},&quot;a8603676-b601-47fb-b710-63c710261328&quot;:{&quot;type&quot;:&quot;FIGURE_OBJECT&quot;,&quot;id&quot;:&quot;a8603676-b601-47fb-b710-63c710261328&quot;,&quot;relativeTransform&quot;:{&quot;translate&quot;:{&quot;x&quot;:-3.9319764028399966,&quot;y&quot;:0},&quot;rotate&quot;:0},&quot;opacity&quot;:1,&quot;path&quot;:{&quot;type&quot;:&quot;POLY_LINE&quot;,&quot;points&quot;:[{&quot;x&quot;:0,&quot;y&quot;:-76.21763219571596},{&quot;x&quot;:0,&quot;y&quot;:76.21763219571596}],&quot;closed&quot;:false},&quot;pathStyles&quot;:[{&quot;type&quot;:&quot;FILL&quot;,&quot;fillStyle&quot;:&quot;transparent&quot;},{&quot;type&quot;:&quot;STROKE&quot;,&quot;strokeStyle&quot;:&quot;#232323&quot;,&quot;lineWidth&quot;:0.788706991550239,&quot;lineJoin&quot;:&quot;round&quot;,&quot;dashArray&quot;:[2,2]}],&quot;isLocked&quot;:false,&quot;parent&quot;:{&quot;type&quot;:&quot;CHILD&quot;,&quot;parentId&quot;:&quot;fad3a17f-1f03-4331-ae70-50660224746b&quot;,&quot;order&quot;:&quot;7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172c8f63-ec04-45ab-b8d7-57b24abb06f9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172c8f63-ec04-45ab-b8d7-57b24abb06f9&quot;:{&quot;id&quot;:&quot;172c8f63-ec04-45ab-b8d7-57b24abb06f9&quot;,&quot;name&quot;:&quot;table with biomarkers.PNG&quot;,&quot;type&quot;:&quot;FIGURE_OBJECT&quot;,&quot;relativeTransform&quot;:{&quot;translate&quot;:{&quot;x&quot;:122.4995,&quot;y&quot;:-199.85943031657263},&quot;rotate&quot;:0,&quot;skewX&quot;:0,&quot;scale&quot;:{&quot;x&quot;:0.99641,&quot;y&quot;:1.1030416116341177}},&quot;image&quot;:{&quot;url&quot;:&quot;https://core.services.biorender.com/api/uploads/67eaf1270d0ea1710795fb8c/1743450407362_c5d3bd6a-6974-4026-bd9c-848f2bf2b376_icon.png&quot;,&quot;fallbackUrl&quot;:&quot;https://core.services.biorender.com/api/uploads/67eaf1270d0ea1710795fb8c/1743450407362_c5d3bd6a-6974-4026-bd9c-848f2bf2b376_icon.png&quot;,&quot;isPremium&quot;:false,&quot;isSignedURL&quot;:true,&quot;size&quot;:{&quot;x&quot;:300,&quot;y&quot;:129.89690721649484}},&quot;source&quot;:{&quot;id&quot;:&quot;67eaf1270d0ea1710795fb8c&quot;,&quot;type&quot;:&quot;UPLOADS&quot;},&quot;isPremium&quot;:false,&quot;parent&quot;:{&quot;type&quot;:&quot;CHILD&quot;,&quot;parentId&quot;:&quot;883e0918-df9f-4401-b3e9-4278bde50d6e&quot;,&quot;order&quot;:&quot;9995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7eadbd7c777ef1343361d75"/>
  <p:tag name="FIGURESLIDEID" val="883e0918-df9f-4401-b3e9-4278bde50d6e"/>
  <p:tag name="SELECTIONIDS" val="287042f9-e62b-4452-857c-793a0e71a005"/>
  <p:tag name="TRANSPARENTBACKGROUND" val="true"/>
  <p:tag name="VERSION" val="1743513591109"/>
  <p:tag name="TITLE" val="JumpACL"/>
  <p:tag name="CREATORNAME" val="Liubov Arbeeva"/>
  <p:tag name="DATEINSERTED" val="1743513606814"/>
  <p:tag name="DPI" val="300"/>
  <p:tag name="BIOJSON" val="{&quot;id&quot;:&quot;4c948911-64b2-4e4e-b6ee-25be9551dd62&quot;,&quot;objects&quot;:{&quot;287042f9-e62b-4452-857c-793a0e71a005&quot;:{&quot;type&quot;:&quot;FIGURE_OBJECT&quot;,&quot;id&quot;:&quot;287042f9-e62b-4452-857c-793a0e71a005&quot;,&quot;relativeTransform&quot;:{&quot;translate&quot;:{&quot;x&quot;:-269.9839999999998,&quot;y&quot;:-224.21999999999994},&quot;rotate&quot;:0},&quot;opacity&quot;:1,&quot;path&quot;:{&quot;type&quot;:&quot;RECT&quot;,&quot;size&quot;:{&quot;x&quot;:395.99999999999994,&quot;y&quot;:212.56000000000017},&quot;cornerRounding&quot;:{&quot;type&quot;:&quot;ARC_LENGTH&quot;,&quot;global&quot;:39.269908169872416}},&quot;pathStyles&quot;:[{&quot;type&quot;:&quot;FILL&quot;,&quot;fillStyle&quot;:&quot;#EEF4FB&quot;},{&quot;type&quot;:&quot;STROKE&quot;,&quot;strokeStyle&quot;:&quot;#95AAD3&quot;,&quot;lineWidth&quot;:2,&quot;lineJoin&quot;:&quot;round&quot;}],&quot;isLocked&quot;:false,&quot;parent&quot;:{&quot;type&quot;:&quot;CHILD&quot;,&quot;parentId&quot;:&quot;883e0918-df9f-4401-b3e9-4278bde50d6e&quot;,&quot;order&quot;:&quot;9997&quot;}},&quot;883e0918-df9f-4401-b3e9-4278bde50d6e&quot;:{&quot;id&quot;:&quot;883e0918-df9f-4401-b3e9-4278bde50d6e&quot;,&quot;type&quot;:&quot;FIGURE_OBJECT&quot;,&quot;document&quot;:{&quot;type&quot;:&quot;FIGURE&quot;,&quot;canvasType&quot;:&quot;FIGURE&quot;,&quot;units&quot;:&quot;in&quot;},&quot;parent&quot;:{&quot;parentId&quot;:&quot;4c948911-64b2-4e4e-b6ee-25be9551dd62&quot;,&quot;type&quot;:&quot;DOCUMENT&quot;,&quot;order&quot;:&quot;5&quot;},&quot;layout&quot;:{&quot;sizeRatio&quot;:{&quot;x&quot;:0.88,&quot;y&quot;:0.88},&quot;keepAspectRatio&quot;:false}},&quot;4c948911-64b2-4e4e-b6ee-25be9551dd62&quot;:{&quot;id&quot;:&quot;4c948911-64b2-4e4e-b6ee-25be9551dd62&quot;,&quot;type&quot;:&quot;FIGURE_OBJECT&quot;,&quot;document&quot;:{&quot;type&quot;:&quot;DOCUMENT_GROUP&quot;,&quot;canvasType&quot;:&quot;FIGURE&quot;,&quot;units&quot;:&quot;in&quot;}}}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1</TotalTime>
  <Words>154</Words>
  <Application>Microsoft Office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Roboto</vt:lpstr>
      <vt:lpstr>Times New Roman</vt:lpstr>
      <vt:lpstr>Office Theme</vt:lpstr>
      <vt:lpstr>PowerPoint Presentation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Arbeeva, Liubov</cp:lastModifiedBy>
  <cp:revision>7</cp:revision>
  <dcterms:created xsi:type="dcterms:W3CDTF">2025-04-01T13:20:07Z</dcterms:created>
  <dcterms:modified xsi:type="dcterms:W3CDTF">2025-04-11T17:36:14Z</dcterms:modified>
</cp:coreProperties>
</file>